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76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8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48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72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2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2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1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41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03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1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0173" y="1012455"/>
            <a:ext cx="2272751" cy="289832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7751" y="1012455"/>
            <a:ext cx="4455492" cy="289832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8755" y="1101028"/>
            <a:ext cx="2111672" cy="280974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 rot="16200000">
            <a:off x="-492903" y="2197006"/>
            <a:ext cx="25824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cs typeface="Arial" panose="020B0604020202020204" pitchFamily="34" charset="0"/>
              </a:rPr>
              <a:t>Burst duration in the second dark challenge (%)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6200000">
            <a:off x="2923908" y="2214160"/>
            <a:ext cx="26167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cs typeface="Arial" panose="020B0604020202020204" pitchFamily="34" charset="0"/>
              </a:rPr>
              <a:t>Travel distance in the first minute (mm)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520244" y="1297590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5" name="矩形 14"/>
          <p:cNvSpPr/>
          <p:nvPr/>
        </p:nvSpPr>
        <p:spPr>
          <a:xfrm>
            <a:off x="6117138" y="1752701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8550900" y="826299"/>
            <a:ext cx="1060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cs typeface="Arial" panose="020B0604020202020204" pitchFamily="34" charset="0"/>
              </a:rPr>
              <a:t>PMA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675271" y="826299"/>
            <a:ext cx="1060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cs typeface="Arial" panose="020B0604020202020204" pitchFamily="34" charset="0"/>
              </a:rPr>
              <a:t>DMSO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43340" y="533911"/>
            <a:ext cx="3186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/>
              <a:t>a</a:t>
            </a:r>
            <a:endParaRPr lang="zh-CN" altLang="en-US" sz="32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671705" y="533910"/>
            <a:ext cx="3186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/>
              <a:t>b</a:t>
            </a:r>
            <a:endParaRPr lang="zh-CN" altLang="en-US" sz="3200" dirty="0"/>
          </a:p>
        </p:txBody>
      </p:sp>
      <p:sp>
        <p:nvSpPr>
          <p:cNvPr id="20" name="文本框 19"/>
          <p:cNvSpPr txBox="1"/>
          <p:nvPr/>
        </p:nvSpPr>
        <p:spPr>
          <a:xfrm rot="16200000">
            <a:off x="5868614" y="2134657"/>
            <a:ext cx="26167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cs typeface="Arial" panose="020B0604020202020204" pitchFamily="34" charset="0"/>
              </a:rPr>
              <a:t>Travel distance in the first minute (mm)</a:t>
            </a:r>
            <a:endParaRPr lang="zh-CN" altLang="en-US" sz="1600" dirty="0"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502667" y="4366216"/>
            <a:ext cx="1141245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Figure S6.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Zebrafish with developmental PKC over-activation exhibit exaggerated stress response during the second dark challenge and impaired habituation between the two light-dark cycles. (</a:t>
            </a: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PMA-exposed fish has much longer burst duration than the control group in the second dark phase. (</a:t>
            </a: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The activity of the control group is decreased in the initial period of the second dark phase compared with that of the first dark phase. (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5, **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01,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-test).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A76ABFD-1525-4624-9758-9D2B3540DD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57614" y="947793"/>
            <a:ext cx="800968" cy="387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198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119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in Liu</dc:creator>
  <cp:lastModifiedBy>Tain Liu</cp:lastModifiedBy>
  <cp:revision>37</cp:revision>
  <dcterms:created xsi:type="dcterms:W3CDTF">2017-03-22T13:45:29Z</dcterms:created>
  <dcterms:modified xsi:type="dcterms:W3CDTF">2018-07-02T14:21:25Z</dcterms:modified>
</cp:coreProperties>
</file>